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5865"/>
  </p:normalViewPr>
  <p:slideViewPr>
    <p:cSldViewPr snapToGrid="0">
      <p:cViewPr varScale="1">
        <p:scale>
          <a:sx n="99" d="100"/>
          <a:sy n="99" d="100"/>
        </p:scale>
        <p:origin x="1056" y="4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0F27EC-A9DC-0852-8CA2-A3A715DC90A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33CDD13-23EA-F730-A38B-4B5335BECAB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5F47FD-AE06-4D60-970E-7E99B75A9E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455D5-4A5A-CF44-8BA3-216CC28C679C}" type="datetimeFigureOut">
              <a:rPr lang="en-US" smtClean="0"/>
              <a:t>2/2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A35FA1-23A0-E9F6-F0CB-9A7E859B2A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E96104-14FE-A94F-9E59-A22777D0AF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70742-73A8-9B44-BCC6-15897D2109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1862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E58247-3341-B081-AD8D-651A0AA2A6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E1261F0-1F2C-EA89-72E8-1D06BA3458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E7E8C9-1F64-7213-52EC-9D4085AF72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455D5-4A5A-CF44-8BA3-216CC28C679C}" type="datetimeFigureOut">
              <a:rPr lang="en-US" smtClean="0"/>
              <a:t>2/2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6C380D-237E-9588-8B16-7EE6D71B86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F713D1-355A-436A-553D-DBB4985F7A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70742-73A8-9B44-BCC6-15897D2109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62420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C825955-9CF5-F7E4-9FEC-56D8F1BCA03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30680EB-C847-328D-A90C-5D303B3498C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2CAECC-F51B-A958-F656-8636EF8001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455D5-4A5A-CF44-8BA3-216CC28C679C}" type="datetimeFigureOut">
              <a:rPr lang="en-US" smtClean="0"/>
              <a:t>2/2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51D12C-1F4D-8502-06D1-11DE7417B6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E4E762-042E-0389-17E3-998E5443DF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70742-73A8-9B44-BCC6-15897D2109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87676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BC938F-5C3C-29BC-D1F2-5525A088CD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4A8433E-0BD0-9D6C-21DB-79A6A21B5D3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C703C0-47DC-D3BB-34D7-D70E4E06D7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455D5-4A5A-CF44-8BA3-216CC28C679C}" type="datetimeFigureOut">
              <a:rPr lang="en-US" smtClean="0"/>
              <a:t>2/2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EAF2C0-B9EF-2D59-66EC-DBB4A49396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B984B0-1E88-9AD7-72E1-6F4BC298BC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70742-73A8-9B44-BCC6-15897D2109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39492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738992-F628-38F8-0BAB-20677B5FE8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F698C4A-EEFA-532C-1764-6FF6B5464B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B7674B-1983-2F0B-5C45-DB835661BD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455D5-4A5A-CF44-8BA3-216CC28C679C}" type="datetimeFigureOut">
              <a:rPr lang="en-US" smtClean="0"/>
              <a:t>2/2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0DB29A-CA23-B728-8363-C58F995988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A7A705-C032-5F10-03CC-13163931D9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70742-73A8-9B44-BCC6-15897D2109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73475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932957-80D2-222F-83CF-F512B3F4EA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BBE0E3F-AC54-F938-5430-B8521488E25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207A9B0-16DE-903C-7D83-F2A66AFA15C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4A6D610-F6D1-1540-28CF-C8B92D1699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455D5-4A5A-CF44-8BA3-216CC28C679C}" type="datetimeFigureOut">
              <a:rPr lang="en-US" smtClean="0"/>
              <a:t>2/27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C208881-1630-4FB5-1C68-78A44DC5EB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C552C8F-D8D9-0C90-3C5E-9D83AEBC33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70742-73A8-9B44-BCC6-15897D2109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3530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D5641B-9AB4-E3FA-BE01-EF20D08880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F10B556-3FCA-0097-C508-8A8158B5EA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C2B29A8-E3D2-C4DD-CDB2-74261448949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A68A3C4-383C-1074-92A5-290BD5F2E5E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31E04CF-B2C2-E083-7C9B-FEC44963F2D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B898ACC-743A-60D8-DA9C-19744BF346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455D5-4A5A-CF44-8BA3-216CC28C679C}" type="datetimeFigureOut">
              <a:rPr lang="en-US" smtClean="0"/>
              <a:t>2/27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E4291AF-23DD-6431-00CD-DB203C0C60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C8DA291-0BE2-E2DC-8E8E-8C8331AE8E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70742-73A8-9B44-BCC6-15897D2109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3497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37BDB8-CF5D-7946-BF5F-018858159A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A8A964F-BBEC-0EC1-6E3B-CF4A9982C3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455D5-4A5A-CF44-8BA3-216CC28C679C}" type="datetimeFigureOut">
              <a:rPr lang="en-US" smtClean="0"/>
              <a:t>2/27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8A7E04F-FDBE-2CA7-273F-82ACA20D25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4D3DAAA-3E22-3701-E24F-397732F68F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70742-73A8-9B44-BCC6-15897D2109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60406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730640A-56A3-4B45-39AA-68A702A2A5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455D5-4A5A-CF44-8BA3-216CC28C679C}" type="datetimeFigureOut">
              <a:rPr lang="en-US" smtClean="0"/>
              <a:t>2/27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E4EB179-384C-9D1C-41B7-83E58B9E1A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0422989-BDD8-9AEC-792E-4132ECDF8A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70742-73A8-9B44-BCC6-15897D2109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22809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491F89-DA59-B437-396B-188E2B5F5C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F8DCDAF-3DA8-E908-9CA3-7D095DDD9C4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7DE3164-5288-3478-7B97-1EDC8F09994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F02475A-05EE-BC2B-753A-527C1AAB7B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455D5-4A5A-CF44-8BA3-216CC28C679C}" type="datetimeFigureOut">
              <a:rPr lang="en-US" smtClean="0"/>
              <a:t>2/27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8C16142-44A1-1A35-542D-7E2EDF9F0C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EC808EE-D945-C51A-1FE3-B7670120D9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70742-73A8-9B44-BCC6-15897D2109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99100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AF6271-FE75-2AEC-9126-C493225D39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8EF7FAF-374E-D4BA-979E-9ACB3D7E1D5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BF6FC6E-E73C-C3F6-69F8-BF017743351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5157BF3-6A25-1A4A-9B98-E4C22691D7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455D5-4A5A-CF44-8BA3-216CC28C679C}" type="datetimeFigureOut">
              <a:rPr lang="en-US" smtClean="0"/>
              <a:t>2/27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46D75FF-16B7-C0AB-81BE-B17F57413F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DD27DDD-A685-7D98-9087-7928369342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70742-73A8-9B44-BCC6-15897D2109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79139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49892A1-87F1-BDDC-AB6D-CAF7B85660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4F14D8-C3C8-9B30-F248-D252FE8AF6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D92274-1650-448E-69E8-734F90C4296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57455D5-4A5A-CF44-8BA3-216CC28C679C}" type="datetimeFigureOut">
              <a:rPr lang="en-US" smtClean="0"/>
              <a:t>2/2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7F4FF8-6895-AF6B-474A-C5B127B5158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A28EA3-5245-F4B1-1F48-C3D7EBFEBD9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0F70742-73A8-9B44-BCC6-15897D2109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28666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screenshot of a computer&#10;&#10;AI-generated content may be incorrect.">
            <a:extLst>
              <a:ext uri="{FF2B5EF4-FFF2-40B4-BE49-F238E27FC236}">
                <a16:creationId xmlns:a16="http://schemas.microsoft.com/office/drawing/2014/main" id="{46408496-5053-D4CE-1985-E0572B50438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3032" y="867506"/>
            <a:ext cx="2782580" cy="2862626"/>
          </a:xfrm>
          <a:prstGeom prst="rect">
            <a:avLst/>
          </a:prstGeom>
        </p:spPr>
      </p:pic>
      <p:pic>
        <p:nvPicPr>
          <p:cNvPr id="7" name="Picture 6" descr="A green string of a protein&#10;&#10;AI-generated content may be incorrect.">
            <a:extLst>
              <a:ext uri="{FF2B5EF4-FFF2-40B4-BE49-F238E27FC236}">
                <a16:creationId xmlns:a16="http://schemas.microsoft.com/office/drawing/2014/main" id="{A0A4FA24-C72F-35EA-1C70-C9FDE7176F1D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4542"/>
          <a:stretch/>
        </p:blipFill>
        <p:spPr>
          <a:xfrm>
            <a:off x="1498732" y="3742694"/>
            <a:ext cx="1583068" cy="1962351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B9CC9560-7EED-45C4-4AA5-15C0C5782763}"/>
              </a:ext>
            </a:extLst>
          </p:cNvPr>
          <p:cNvSpPr txBox="1"/>
          <p:nvPr/>
        </p:nvSpPr>
        <p:spPr>
          <a:xfrm>
            <a:off x="583032" y="419081"/>
            <a:ext cx="345044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20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Sequence Annotations in 3D: 6F0O</a:t>
            </a:r>
            <a:r>
              <a:rPr lang="en-GB" sz="1200" i="0" baseline="300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Picture 10" descr="A screenshot of a computer&#10;&#10;AI-generated content may be incorrect.">
            <a:extLst>
              <a:ext uri="{FF2B5EF4-FFF2-40B4-BE49-F238E27FC236}">
                <a16:creationId xmlns:a16="http://schemas.microsoft.com/office/drawing/2014/main" id="{9F133D0B-F151-CABF-A648-D0AD3D172E2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72867" y="802635"/>
            <a:ext cx="2706263" cy="2955283"/>
          </a:xfrm>
          <a:prstGeom prst="rect">
            <a:avLst/>
          </a:prstGeom>
        </p:spPr>
      </p:pic>
      <p:pic>
        <p:nvPicPr>
          <p:cNvPr id="13" name="Picture 12" descr="A green and white structure&#10;&#10;AI-generated content may be incorrect.">
            <a:extLst>
              <a:ext uri="{FF2B5EF4-FFF2-40B4-BE49-F238E27FC236}">
                <a16:creationId xmlns:a16="http://schemas.microsoft.com/office/drawing/2014/main" id="{86AB9CBD-1AB0-C413-FBED-051DFF36552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965012" y="3730132"/>
            <a:ext cx="2149719" cy="2157144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D3AAE201-1D2E-B4A7-3058-1DADEB3B90F5}"/>
              </a:ext>
            </a:extLst>
          </p:cNvPr>
          <p:cNvSpPr txBox="1"/>
          <p:nvPr/>
        </p:nvSpPr>
        <p:spPr>
          <a:xfrm>
            <a:off x="4798857" y="325378"/>
            <a:ext cx="270626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Sequence Annotations in 3D: 3BTA</a:t>
            </a:r>
            <a:r>
              <a:rPr lang="en-GB" sz="1200" i="0" baseline="300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  <a:endParaRPr 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BC06117-32BD-479D-629A-805A3194B679}"/>
              </a:ext>
            </a:extLst>
          </p:cNvPr>
          <p:cNvSpPr txBox="1"/>
          <p:nvPr/>
        </p:nvSpPr>
        <p:spPr>
          <a:xfrm>
            <a:off x="8725322" y="329167"/>
            <a:ext cx="288364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Sequence Annotations in 3D: 5VGV</a:t>
            </a:r>
            <a:r>
              <a:rPr lang="en-GB" sz="1200" i="0" baseline="300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3</a:t>
            </a:r>
            <a:endParaRPr 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Picture 20" descr="A screenshot of a computer&#10;&#10;AI-generated content may be incorrect.">
            <a:extLst>
              <a:ext uri="{FF2B5EF4-FFF2-40B4-BE49-F238E27FC236}">
                <a16:creationId xmlns:a16="http://schemas.microsoft.com/office/drawing/2014/main" id="{CF12B81D-993F-CB2D-07AC-639526CE1FC8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b="1610"/>
          <a:stretch/>
        </p:blipFill>
        <p:spPr>
          <a:xfrm>
            <a:off x="8321986" y="802635"/>
            <a:ext cx="2706262" cy="2927497"/>
          </a:xfrm>
          <a:prstGeom prst="rect">
            <a:avLst/>
          </a:prstGeom>
        </p:spPr>
      </p:pic>
      <p:pic>
        <p:nvPicPr>
          <p:cNvPr id="25" name="Picture 24" descr="A green spiraling object&#10;&#10;AI-generated content may be incorrect.">
            <a:extLst>
              <a:ext uri="{FF2B5EF4-FFF2-40B4-BE49-F238E27FC236}">
                <a16:creationId xmlns:a16="http://schemas.microsoft.com/office/drawing/2014/main" id="{B213CE56-C91E-882A-ED28-1D492A8B67A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9066632" y="3764147"/>
            <a:ext cx="1856887" cy="2199547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4F222A34-B9F0-B9E6-443B-FEFC8C248D27}"/>
              </a:ext>
            </a:extLst>
          </p:cNvPr>
          <p:cNvSpPr txBox="1"/>
          <p:nvPr/>
        </p:nvSpPr>
        <p:spPr>
          <a:xfrm>
            <a:off x="1169454" y="5667152"/>
            <a:ext cx="10268497" cy="107721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228600" indent="-228600" algn="just">
              <a:buAutoNum type="arabicPeriod"/>
            </a:pPr>
            <a:r>
              <a:rPr lang="en-GB" sz="900" b="0" i="0" dirty="0">
                <a:solidFill>
                  <a:srgbClr val="21212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avies JR, Rees J, Liu SM, Acharya KR. High resolution crystal structures of Clostridium botulinum neurotoxin A3 and A4 binding domains. J Struct Biol. 2018 May;202(2):113-117. </a:t>
            </a:r>
            <a:r>
              <a:rPr lang="en-GB" sz="900" b="0" i="0" dirty="0" err="1">
                <a:solidFill>
                  <a:srgbClr val="21212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oi</a:t>
            </a:r>
            <a:r>
              <a:rPr lang="en-GB" sz="900" b="0" i="0" dirty="0">
                <a:solidFill>
                  <a:srgbClr val="21212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: 10.1016/j.jsb.2017.12.010. </a:t>
            </a:r>
            <a:r>
              <a:rPr lang="en-GB" sz="900" b="0" i="0" dirty="0" err="1">
                <a:solidFill>
                  <a:srgbClr val="21212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pub</a:t>
            </a:r>
            <a:r>
              <a:rPr lang="en-GB" sz="900" b="0" i="0" dirty="0">
                <a:solidFill>
                  <a:srgbClr val="21212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2017 Dec 26. PMID: 29288126.</a:t>
            </a:r>
          </a:p>
          <a:p>
            <a:pPr marL="228600" indent="-228600" algn="just">
              <a:buAutoNum type="arabicPeriod"/>
            </a:pPr>
            <a:r>
              <a:rPr lang="en-GB" sz="900" b="0" i="0" dirty="0">
                <a:solidFill>
                  <a:srgbClr val="21212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acy DB, </a:t>
            </a:r>
            <a:r>
              <a:rPr lang="en-GB" sz="900" b="0" i="0" dirty="0" err="1">
                <a:solidFill>
                  <a:srgbClr val="21212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epp</a:t>
            </a:r>
            <a:r>
              <a:rPr lang="en-GB" sz="900" b="0" i="0" dirty="0">
                <a:solidFill>
                  <a:srgbClr val="21212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W, Cohen AC, DasGupta BR, Stevens RC. Crystal structure of botulinum neurotoxin type A and implications for toxicity. Nat Struct Biol. 1998 Oct;5(10):898-902. </a:t>
            </a:r>
            <a:r>
              <a:rPr lang="en-GB" sz="900" b="0" i="0" dirty="0" err="1">
                <a:solidFill>
                  <a:srgbClr val="21212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oi</a:t>
            </a:r>
            <a:r>
              <a:rPr lang="en-GB" sz="900" b="0" i="0" dirty="0">
                <a:solidFill>
                  <a:srgbClr val="21212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: 10.1038/2338. PMID: 9783750.</a:t>
            </a:r>
          </a:p>
          <a:p>
            <a:pPr marL="228600" indent="-228600" algn="just">
              <a:buAutoNum type="arabicPeriod"/>
            </a:pPr>
            <a:r>
              <a:rPr lang="en-GB" sz="900" b="0" i="0" dirty="0">
                <a:solidFill>
                  <a:srgbClr val="21212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remer PT, Pellett S, Carolan JP, </a:t>
            </a:r>
            <a:r>
              <a:rPr lang="en-GB" sz="900" b="0" i="0" dirty="0" err="1">
                <a:solidFill>
                  <a:srgbClr val="21212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epp</a:t>
            </a:r>
            <a:r>
              <a:rPr lang="en-GB" sz="900" b="0" i="0" dirty="0">
                <a:solidFill>
                  <a:srgbClr val="21212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WH, Eubanks LM, Allen KN, Johnson EA, Janda KD. Metal Ions Effectively Ablate the Action of Botulinum Neurotoxin A. J Am Chem Soc. 2017 May 31;139(21):7264-7272. </a:t>
            </a:r>
            <a:r>
              <a:rPr lang="en-GB" sz="900" b="0" i="0" dirty="0" err="1">
                <a:solidFill>
                  <a:srgbClr val="21212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oi</a:t>
            </a:r>
            <a:r>
              <a:rPr lang="en-GB" sz="900" b="0" i="0" dirty="0">
                <a:solidFill>
                  <a:srgbClr val="21212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: 10.1021/jacs.7b01084. </a:t>
            </a:r>
            <a:r>
              <a:rPr lang="en-GB" sz="900" b="0" i="0" dirty="0" err="1">
                <a:solidFill>
                  <a:srgbClr val="21212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pub</a:t>
            </a:r>
            <a:r>
              <a:rPr lang="en-GB" sz="900" b="0" i="0" dirty="0">
                <a:solidFill>
                  <a:srgbClr val="21212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2017 May 19. PMID: 28475321; PMCID: PMC5612488.</a:t>
            </a:r>
          </a:p>
          <a:p>
            <a:pPr marL="228600" indent="-228600" algn="just">
              <a:buAutoNum type="arabicPeriod"/>
            </a:pP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401083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0A56E1CF-8B1A-71FB-204F-8F6D742BC7B6}"/>
              </a:ext>
            </a:extLst>
          </p:cNvPr>
          <p:cNvSpPr txBox="1"/>
          <p:nvPr/>
        </p:nvSpPr>
        <p:spPr>
          <a:xfrm>
            <a:off x="762122" y="455869"/>
            <a:ext cx="283631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Sequence Annotations in 3D: 3V0B </a:t>
            </a:r>
            <a:r>
              <a:rPr lang="en-GB" sz="1200" i="0" baseline="300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 descr="A screenshot of a computer&#10;&#10;AI-generated content may be incorrect.">
            <a:extLst>
              <a:ext uri="{FF2B5EF4-FFF2-40B4-BE49-F238E27FC236}">
                <a16:creationId xmlns:a16="http://schemas.microsoft.com/office/drawing/2014/main" id="{44B1B171-A90D-FF8D-ED0C-7D584316F4C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1513" y="941171"/>
            <a:ext cx="2651140" cy="2866294"/>
          </a:xfrm>
          <a:prstGeom prst="rect">
            <a:avLst/>
          </a:prstGeom>
        </p:spPr>
      </p:pic>
      <p:pic>
        <p:nvPicPr>
          <p:cNvPr id="6" name="Picture 5" descr="A close-up of a structure&#10;&#10;AI-generated content may be incorrect.">
            <a:extLst>
              <a:ext uri="{FF2B5EF4-FFF2-40B4-BE49-F238E27FC236}">
                <a16:creationId xmlns:a16="http://schemas.microsoft.com/office/drawing/2014/main" id="{CA20228F-8912-F8C3-38DD-9BD46599368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29642" y="4053749"/>
            <a:ext cx="1780051" cy="1832496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E38A1C2F-8E0E-61B4-6636-13C5A7736496}"/>
              </a:ext>
            </a:extLst>
          </p:cNvPr>
          <p:cNvSpPr txBox="1"/>
          <p:nvPr/>
        </p:nvSpPr>
        <p:spPr>
          <a:xfrm>
            <a:off x="4123965" y="464303"/>
            <a:ext cx="278163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Sequence Annotations in 3D: 4LO0</a:t>
            </a:r>
            <a:r>
              <a:rPr lang="en-GB" sz="1200" i="0" baseline="300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5</a:t>
            </a:r>
            <a:endParaRPr 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Picture 10" descr="A screenshot of a computer&#10;&#10;AI-generated content may be incorrect.">
            <a:extLst>
              <a:ext uri="{FF2B5EF4-FFF2-40B4-BE49-F238E27FC236}">
                <a16:creationId xmlns:a16="http://schemas.microsoft.com/office/drawing/2014/main" id="{F28A158A-167B-B92F-52E3-D6E173BAC26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53558" y="941171"/>
            <a:ext cx="2651140" cy="2838928"/>
          </a:xfrm>
          <a:prstGeom prst="rect">
            <a:avLst/>
          </a:prstGeom>
        </p:spPr>
      </p:pic>
      <p:pic>
        <p:nvPicPr>
          <p:cNvPr id="13" name="Picture 12" descr="A close-up of a model of a protein&#10;&#10;AI-generated content may be incorrect.">
            <a:extLst>
              <a:ext uri="{FF2B5EF4-FFF2-40B4-BE49-F238E27FC236}">
                <a16:creationId xmlns:a16="http://schemas.microsoft.com/office/drawing/2014/main" id="{1EA2394F-8EEF-82C9-1C0E-3BC6B88098E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238192" y="3991803"/>
            <a:ext cx="1680714" cy="1956387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4EFE60CE-A04F-CEC5-BF88-2880E2E6D616}"/>
              </a:ext>
            </a:extLst>
          </p:cNvPr>
          <p:cNvSpPr txBox="1"/>
          <p:nvPr/>
        </p:nvSpPr>
        <p:spPr>
          <a:xfrm>
            <a:off x="7651957" y="464303"/>
            <a:ext cx="278163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Sequence Annotations in 3D: 4LO4 </a:t>
            </a:r>
            <a:r>
              <a:rPr lang="en-GB" sz="1200" i="0" baseline="300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Picture 16" descr="A screenshot of a computer&#10;&#10;AI-generated content may be incorrect.">
            <a:extLst>
              <a:ext uri="{FF2B5EF4-FFF2-40B4-BE49-F238E27FC236}">
                <a16:creationId xmlns:a16="http://schemas.microsoft.com/office/drawing/2014/main" id="{7415328B-2B20-8518-BABE-135493A14A9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905603" y="941171"/>
            <a:ext cx="3307343" cy="2899085"/>
          </a:xfrm>
          <a:prstGeom prst="rect">
            <a:avLst/>
          </a:prstGeom>
        </p:spPr>
      </p:pic>
      <p:pic>
        <p:nvPicPr>
          <p:cNvPr id="19" name="Picture 18" descr="A close-up of a structure&#10;&#10;AI-generated content may be incorrect.">
            <a:extLst>
              <a:ext uri="{FF2B5EF4-FFF2-40B4-BE49-F238E27FC236}">
                <a16:creationId xmlns:a16="http://schemas.microsoft.com/office/drawing/2014/main" id="{0F5CAA08-1339-1957-1EE4-E6F54010383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164631" y="4053749"/>
            <a:ext cx="1468767" cy="1787329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C3675445-FF65-84C9-54F8-6B18F8D40A38}"/>
              </a:ext>
            </a:extLst>
          </p:cNvPr>
          <p:cNvSpPr txBox="1"/>
          <p:nvPr/>
        </p:nvSpPr>
        <p:spPr>
          <a:xfrm>
            <a:off x="703906" y="5948190"/>
            <a:ext cx="1077117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900" b="0" i="0" dirty="0">
                <a:solidFill>
                  <a:srgbClr val="212121"/>
                </a:solidFill>
                <a:effectLst/>
                <a:latin typeface="system-ui"/>
              </a:rPr>
              <a:t>4. Gu S, Rumpel S, Zhou J, </a:t>
            </a:r>
            <a:r>
              <a:rPr lang="en-GB" sz="900" b="0" i="0" dirty="0" err="1">
                <a:solidFill>
                  <a:srgbClr val="212121"/>
                </a:solidFill>
                <a:effectLst/>
                <a:latin typeface="system-ui"/>
              </a:rPr>
              <a:t>Strotmeier</a:t>
            </a:r>
            <a:r>
              <a:rPr lang="en-GB" sz="900" b="0" i="0" dirty="0">
                <a:solidFill>
                  <a:srgbClr val="212121"/>
                </a:solidFill>
                <a:effectLst/>
                <a:latin typeface="system-ui"/>
              </a:rPr>
              <a:t> J, </a:t>
            </a:r>
            <a:r>
              <a:rPr lang="en-GB" sz="900" b="0" i="0" dirty="0" err="1">
                <a:solidFill>
                  <a:srgbClr val="212121"/>
                </a:solidFill>
                <a:effectLst/>
                <a:latin typeface="system-ui"/>
              </a:rPr>
              <a:t>Bigalke</a:t>
            </a:r>
            <a:r>
              <a:rPr lang="en-GB" sz="900" b="0" i="0" dirty="0">
                <a:solidFill>
                  <a:srgbClr val="212121"/>
                </a:solidFill>
                <a:effectLst/>
                <a:latin typeface="system-ui"/>
              </a:rPr>
              <a:t> H, Perry K, Shoemaker CB, Rummel A, Jin R. Botulinum neurotoxin is shielded by NTNHA in an interlocked complex. Science. 2012 Feb 24;335(6071):977-81. </a:t>
            </a:r>
            <a:r>
              <a:rPr lang="en-GB" sz="900" b="0" i="0" dirty="0" err="1">
                <a:solidFill>
                  <a:srgbClr val="212121"/>
                </a:solidFill>
                <a:effectLst/>
                <a:latin typeface="system-ui"/>
              </a:rPr>
              <a:t>doi</a:t>
            </a:r>
            <a:r>
              <a:rPr lang="en-GB" sz="900" b="0" i="0" dirty="0">
                <a:solidFill>
                  <a:srgbClr val="212121"/>
                </a:solidFill>
                <a:effectLst/>
                <a:latin typeface="system-ui"/>
              </a:rPr>
              <a:t>: 10.1126/science.1214270. PMID: 22363010; PMCID: PMC3545708.</a:t>
            </a:r>
          </a:p>
          <a:p>
            <a:r>
              <a:rPr lang="en-GB" sz="900" dirty="0">
                <a:solidFill>
                  <a:srgbClr val="212121"/>
                </a:solidFill>
                <a:latin typeface="system-ui"/>
              </a:rPr>
              <a:t>5. </a:t>
            </a:r>
            <a:r>
              <a:rPr lang="en-GB" sz="900" b="0" i="0" dirty="0">
                <a:solidFill>
                  <a:srgbClr val="212121"/>
                </a:solidFill>
                <a:effectLst/>
                <a:latin typeface="system-ui"/>
              </a:rPr>
              <a:t>Lee K, Gu S, Jin L, Le TT, Cheng LW, </a:t>
            </a:r>
            <a:r>
              <a:rPr lang="en-GB" sz="900" b="0" i="0" dirty="0" err="1">
                <a:solidFill>
                  <a:srgbClr val="212121"/>
                </a:solidFill>
                <a:effectLst/>
                <a:latin typeface="system-ui"/>
              </a:rPr>
              <a:t>Strotmeier</a:t>
            </a:r>
            <a:r>
              <a:rPr lang="en-GB" sz="900" b="0" i="0" dirty="0">
                <a:solidFill>
                  <a:srgbClr val="212121"/>
                </a:solidFill>
                <a:effectLst/>
                <a:latin typeface="system-ui"/>
              </a:rPr>
              <a:t> J, </a:t>
            </a:r>
            <a:r>
              <a:rPr lang="en-GB" sz="900" b="0" i="0" dirty="0" err="1">
                <a:solidFill>
                  <a:srgbClr val="212121"/>
                </a:solidFill>
                <a:effectLst/>
                <a:latin typeface="system-ui"/>
              </a:rPr>
              <a:t>Kruel</a:t>
            </a:r>
            <a:r>
              <a:rPr lang="en-GB" sz="900" b="0" i="0" dirty="0">
                <a:solidFill>
                  <a:srgbClr val="212121"/>
                </a:solidFill>
                <a:effectLst/>
                <a:latin typeface="system-ui"/>
              </a:rPr>
              <a:t> AM, Yao G, Perry K, Rummel A, Jin R. Structure of a bimodular botulinum neurotoxin complex provides insights into its oral toxicity. </a:t>
            </a:r>
            <a:r>
              <a:rPr lang="en-GB" sz="900" b="0" i="0" dirty="0" err="1">
                <a:solidFill>
                  <a:srgbClr val="212121"/>
                </a:solidFill>
                <a:effectLst/>
                <a:latin typeface="system-ui"/>
              </a:rPr>
              <a:t>PLoS</a:t>
            </a:r>
            <a:r>
              <a:rPr lang="en-GB" sz="900" b="0" i="0" dirty="0">
                <a:solidFill>
                  <a:srgbClr val="212121"/>
                </a:solidFill>
                <a:effectLst/>
                <a:latin typeface="system-ui"/>
              </a:rPr>
              <a:t> </a:t>
            </a:r>
            <a:r>
              <a:rPr lang="en-GB" sz="900" b="0" i="0" dirty="0" err="1">
                <a:solidFill>
                  <a:srgbClr val="212121"/>
                </a:solidFill>
                <a:effectLst/>
                <a:latin typeface="system-ui"/>
              </a:rPr>
              <a:t>Pathog</a:t>
            </a:r>
            <a:r>
              <a:rPr lang="en-GB" sz="900" b="0" i="0" dirty="0">
                <a:solidFill>
                  <a:srgbClr val="212121"/>
                </a:solidFill>
                <a:effectLst/>
                <a:latin typeface="system-ui"/>
              </a:rPr>
              <a:t>. 2013;9(10):e1003690. </a:t>
            </a:r>
            <a:r>
              <a:rPr lang="en-GB" sz="900" b="0" i="0" dirty="0" err="1">
                <a:solidFill>
                  <a:srgbClr val="212121"/>
                </a:solidFill>
                <a:effectLst/>
                <a:latin typeface="system-ui"/>
              </a:rPr>
              <a:t>doi</a:t>
            </a:r>
            <a:r>
              <a:rPr lang="en-GB" sz="900" b="0" i="0" dirty="0">
                <a:solidFill>
                  <a:srgbClr val="212121"/>
                </a:solidFill>
                <a:effectLst/>
                <a:latin typeface="system-ui"/>
              </a:rPr>
              <a:t>: 10.1371/journal.ppat.1003690. </a:t>
            </a:r>
            <a:r>
              <a:rPr lang="en-GB" sz="900" b="0" i="0" dirty="0" err="1">
                <a:solidFill>
                  <a:srgbClr val="212121"/>
                </a:solidFill>
                <a:effectLst/>
                <a:latin typeface="system-ui"/>
              </a:rPr>
              <a:t>Epub</a:t>
            </a:r>
            <a:r>
              <a:rPr lang="en-GB" sz="900" b="0" i="0" dirty="0">
                <a:solidFill>
                  <a:srgbClr val="212121"/>
                </a:solidFill>
                <a:effectLst/>
                <a:latin typeface="system-ui"/>
              </a:rPr>
              <a:t> 2013 Oct 10. PMID: 24130488; PMCID: PMC3795040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17612444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13</TotalTime>
  <Words>352</Words>
  <Application>Microsoft Macintosh PowerPoint</Application>
  <PresentationFormat>Widescreen</PresentationFormat>
  <Paragraphs>1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system-ui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Eqram Rahman</dc:creator>
  <cp:lastModifiedBy>Eqram Rahman</cp:lastModifiedBy>
  <cp:revision>2</cp:revision>
  <dcterms:created xsi:type="dcterms:W3CDTF">2025-02-23T11:11:34Z</dcterms:created>
  <dcterms:modified xsi:type="dcterms:W3CDTF">2025-02-27T20:37:14Z</dcterms:modified>
</cp:coreProperties>
</file>